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29.jpeg" ContentType="image/jpeg"/>
  <Override PartName="/ppt/media/image3.wmf" ContentType="image/x-wmf"/>
  <Override PartName="/ppt/media/image28.jpeg" ContentType="image/jpeg"/>
  <Override PartName="/ppt/media/image27.jpeg" ContentType="image/jpeg"/>
  <Override PartName="/ppt/media/image10.png" ContentType="image/png"/>
  <Override PartName="/ppt/media/image19.jpeg" ContentType="image/jpeg"/>
  <Override PartName="/ppt/media/image6.wmf" ContentType="image/x-wmf"/>
  <Override PartName="/ppt/media/image24.jpeg" ContentType="image/jpeg"/>
  <Override PartName="/ppt/media/image30.jpeg" ContentType="image/jpeg"/>
  <Override PartName="/ppt/media/image7.wmf" ContentType="image/x-wmf"/>
  <Override PartName="/ppt/media/image20.jpeg" ContentType="image/jpeg"/>
  <Override PartName="/ppt/media/image11.jpeg" ContentType="image/jpeg"/>
  <Override PartName="/ppt/media/image12.jpeg" ContentType="image/jpeg"/>
  <Override PartName="/ppt/media/image8.wmf" ContentType="image/x-wmf"/>
  <Override PartName="/ppt/media/image9.wmf" ContentType="image/x-wmf"/>
  <Override PartName="/ppt/media/image31.jpeg" ContentType="image/jpeg"/>
  <Override PartName="/ppt/media/image25.jpeg" ContentType="image/jpeg"/>
  <Override PartName="/ppt/media/image32.jpeg" ContentType="image/jpeg"/>
  <Override PartName="/ppt/media/image26.jpeg" ContentType="image/jpeg"/>
  <Override PartName="/ppt/media/image4.wmf" ContentType="image/x-wmf"/>
  <Override PartName="/ppt/media/image13.jpeg" ContentType="image/jpeg"/>
  <Override PartName="/ppt/media/image15.jpeg" ContentType="image/jpeg"/>
  <Override PartName="/ppt/media/image23.jpeg" ContentType="image/jpeg"/>
  <Override PartName="/ppt/media/image1.wmf" ContentType="image/x-wmf"/>
  <Override PartName="/ppt/media/image14.jpeg" ContentType="image/jpeg"/>
  <Override PartName="/ppt/media/image5.wmf" ContentType="image/x-wmf"/>
  <Override PartName="/ppt/media/image16.jpeg" ContentType="image/jpeg"/>
  <Override PartName="/ppt/media/image17.jpeg" ContentType="image/jpeg"/>
  <Override PartName="/ppt/media/image18.jpeg" ContentType="image/jpeg"/>
  <Override PartName="/ppt/media/image2.wmf" ContentType="image/x-wmf"/>
  <Override PartName="/ppt/media/image21.jpeg" ContentType="image/jpeg"/>
  <Override PartName="/ppt/media/image2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13716000" cy="17373600"/>
  <p:notesSz cx="6889750" cy="100218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90400" cy="1002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168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l-GR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1252080"/>
            <a:ext cx="2670120" cy="3382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168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B929DEE0-7FC9-43A1-8B45-DD49A1B6FF05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04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AABDDF63-ECE3-41ED-8897-B4DE3EEFA2A4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AA475E45-ADCD-41AC-9462-EBC02DE69800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52DA5-269D-4E66-B8F9-9390FAB440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018D7-F83C-4523-B7BB-70989B59A7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D43B8-6952-4C6D-B546-E3EC8BE65E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C5B052-0BB6-414C-8B68-92FBA84E4D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6702E-1EE7-4C6E-8E52-94606B1357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42BC1-A01E-4B2F-AF21-E97988C8C7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31214-7215-4998-A1BD-93B36A822E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2F7E0-F85E-42F9-AE09-4A37BAC0EC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95160"/>
            <a:ext cx="12344400" cy="134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BFB1B-5233-41FD-90D8-B96F7F73FE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BD52E-CD75-4BAA-9C8C-0E865E230A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5ACF6-ACC4-482A-A74F-49CE9E23AA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DDAA53-289D-4DD3-B269-1102A96DE6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marL="665280" indent="-66528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1" marL="1442880" indent="-5540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2" marL="2219400" indent="-44316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3" marL="3108240" indent="-4428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4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5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6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101720"/>
            <a:ext cx="4343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1D625115-AB87-44F5-AAD0-E780295A117B}" type="slidenum">
              <a:rPr b="0" lang="en-US" sz="2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image" Target="../media/image10.png"/><Relationship Id="rId20" Type="http://schemas.openxmlformats.org/officeDocument/2006/relationships/image" Target="../media/image11.jpeg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image" Target="../media/image13.jpeg"/><Relationship Id="rId3" Type="http://schemas.openxmlformats.org/officeDocument/2006/relationships/image" Target="../media/image14.jpeg"/><Relationship Id="rId4" Type="http://schemas.openxmlformats.org/officeDocument/2006/relationships/image" Target="../media/image15.jpeg"/><Relationship Id="rId5" Type="http://schemas.openxmlformats.org/officeDocument/2006/relationships/image" Target="../media/image16.jpeg"/><Relationship Id="rId6" Type="http://schemas.openxmlformats.org/officeDocument/2006/relationships/image" Target="../media/image17.jpeg"/><Relationship Id="rId7" Type="http://schemas.openxmlformats.org/officeDocument/2006/relationships/image" Target="../media/image18.jpeg"/><Relationship Id="rId8" Type="http://schemas.openxmlformats.org/officeDocument/2006/relationships/image" Target="../media/image19.jpeg"/><Relationship Id="rId9" Type="http://schemas.openxmlformats.org/officeDocument/2006/relationships/image" Target="../media/image20.jpeg"/><Relationship Id="rId10" Type="http://schemas.openxmlformats.org/officeDocument/2006/relationships/image" Target="../media/image21.jpeg"/><Relationship Id="rId11" Type="http://schemas.openxmlformats.org/officeDocument/2006/relationships/image" Target="../media/image22.jpeg"/><Relationship Id="rId12" Type="http://schemas.openxmlformats.org/officeDocument/2006/relationships/image" Target="../media/image23.jpeg"/><Relationship Id="rId13" Type="http://schemas.openxmlformats.org/officeDocument/2006/relationships/image" Target="../media/image24.jpeg"/><Relationship Id="rId14" Type="http://schemas.openxmlformats.org/officeDocument/2006/relationships/image" Target="../media/image25.jpeg"/><Relationship Id="rId15" Type="http://schemas.openxmlformats.org/officeDocument/2006/relationships/image" Target="../media/image26.jpeg"/><Relationship Id="rId16" Type="http://schemas.openxmlformats.org/officeDocument/2006/relationships/image" Target="../media/image27.jpeg"/><Relationship Id="rId17" Type="http://schemas.openxmlformats.org/officeDocument/2006/relationships/image" Target="../media/image28.jpeg"/><Relationship Id="rId18" Type="http://schemas.openxmlformats.org/officeDocument/2006/relationships/image" Target="../media/image29.jpeg"/><Relationship Id="rId19" Type="http://schemas.openxmlformats.org/officeDocument/2006/relationships/image" Target="../media/image30.jpeg"/><Relationship Id="rId20" Type="http://schemas.openxmlformats.org/officeDocument/2006/relationships/image" Target="../media/image31.jpeg"/><Relationship Id="rId21" Type="http://schemas.openxmlformats.org/officeDocument/2006/relationships/image" Target="../media/image32.jpeg"/><Relationship Id="rId22" Type="http://schemas.openxmlformats.org/officeDocument/2006/relationships/slideLayout" Target="../slideLayouts/slideLayout1.xml"/><Relationship Id="rId2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Ομάδα 1"/>
          <p:cNvGrpSpPr/>
          <p:nvPr/>
        </p:nvGrpSpPr>
        <p:grpSpPr>
          <a:xfrm>
            <a:off x="954000" y="1960560"/>
            <a:ext cx="12096720" cy="13711320"/>
            <a:chOff x="954000" y="1960560"/>
            <a:chExt cx="12096720" cy="13711320"/>
          </a:xfrm>
        </p:grpSpPr>
        <p:sp>
          <p:nvSpPr>
            <p:cNvPr id="49" name="42 - TextBox"/>
            <p:cNvSpPr/>
            <p:nvPr/>
          </p:nvSpPr>
          <p:spPr>
            <a:xfrm>
              <a:off x="954000" y="1960560"/>
              <a:ext cx="55224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42 - TextBox"/>
            <p:cNvSpPr/>
            <p:nvPr/>
          </p:nvSpPr>
          <p:spPr>
            <a:xfrm>
              <a:off x="5975280" y="2036520"/>
              <a:ext cx="55548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42 - TextBox"/>
            <p:cNvSpPr/>
            <p:nvPr/>
          </p:nvSpPr>
          <p:spPr>
            <a:xfrm>
              <a:off x="955440" y="6170400"/>
              <a:ext cx="55548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2" name="36 - Ομάδα"/>
            <p:cNvGrpSpPr/>
            <p:nvPr/>
          </p:nvGrpSpPr>
          <p:grpSpPr>
            <a:xfrm>
              <a:off x="1385640" y="6599160"/>
              <a:ext cx="11665080" cy="9072720"/>
              <a:chOff x="1385640" y="6599160"/>
              <a:chExt cx="11665080" cy="9072720"/>
            </a:xfrm>
          </p:grpSpPr>
          <p:graphicFrame>
            <p:nvGraphicFramePr>
              <p:cNvPr id="53" name="Object 18"/>
              <p:cNvGraphicFramePr/>
              <p:nvPr/>
            </p:nvGraphicFramePr>
            <p:xfrm>
              <a:off x="5776920" y="9579240"/>
              <a:ext cx="3024360" cy="270432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54" name="Object 18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5776920" y="9579240"/>
                        <a:ext cx="3024360" cy="27043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5" name="Object 19"/>
              <p:cNvGraphicFramePr/>
              <p:nvPr/>
            </p:nvGraphicFramePr>
            <p:xfrm>
              <a:off x="1564560" y="9621360"/>
              <a:ext cx="2995920" cy="267912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56" name="Object 19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1564560" y="9621360"/>
                        <a:ext cx="2995920" cy="2679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7" name="Object 20"/>
              <p:cNvGraphicFramePr/>
              <p:nvPr/>
            </p:nvGraphicFramePr>
            <p:xfrm>
              <a:off x="5866560" y="12920760"/>
              <a:ext cx="3024360" cy="270432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58" name="Object 20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5866560" y="12920760"/>
                        <a:ext cx="3024360" cy="27043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9" name="Object 21"/>
              <p:cNvGraphicFramePr/>
              <p:nvPr/>
            </p:nvGraphicFramePr>
            <p:xfrm>
              <a:off x="1385640" y="12830400"/>
              <a:ext cx="3308760" cy="281016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60" name="Object 21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1385640" y="12830400"/>
                        <a:ext cx="3308760" cy="28101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1" name="Object 22"/>
              <p:cNvGraphicFramePr/>
              <p:nvPr/>
            </p:nvGraphicFramePr>
            <p:xfrm>
              <a:off x="9899280" y="12853800"/>
              <a:ext cx="3151440" cy="281808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62" name="Object 22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9899280" y="12853800"/>
                        <a:ext cx="3151440" cy="28180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3" name="Object 23"/>
              <p:cNvGraphicFramePr/>
              <p:nvPr/>
            </p:nvGraphicFramePr>
            <p:xfrm>
              <a:off x="9720360" y="6689160"/>
              <a:ext cx="3151440" cy="281808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64" name="Object 23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9720360" y="6689160"/>
                        <a:ext cx="3151440" cy="28180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5" name="Object 24"/>
              <p:cNvGraphicFramePr/>
              <p:nvPr/>
            </p:nvGraphicFramePr>
            <p:xfrm>
              <a:off x="9720360" y="9470160"/>
              <a:ext cx="3151440" cy="281808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66" name="Object 24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9720360" y="9470160"/>
                        <a:ext cx="3151440" cy="28180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7" name="Object 25"/>
              <p:cNvGraphicFramePr/>
              <p:nvPr/>
            </p:nvGraphicFramePr>
            <p:xfrm>
              <a:off x="5508000" y="6735240"/>
              <a:ext cx="3308760" cy="281016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68" name="Object 25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5508000" y="6735240"/>
                        <a:ext cx="3308760" cy="28101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9" name="Object 26"/>
              <p:cNvGraphicFramePr/>
              <p:nvPr/>
            </p:nvGraphicFramePr>
            <p:xfrm>
              <a:off x="1482120" y="6599160"/>
              <a:ext cx="3308760" cy="2958840"/>
            </p:xfrm>
            <a:graphic>
              <a:graphicData uri="http://schemas.openxmlformats.org/presentationml/2006/ole">
                <p:oleObj r:id="rId17" spid="">
                  <p:embed/>
                  <p:pic>
                    <p:nvPicPr>
                      <p:cNvPr id="70" name="Object 26" descr=""/>
                      <p:cNvPicPr/>
                      <p:nvPr/>
                    </p:nvPicPr>
                    <p:blipFill>
                      <a:blip r:embed="rId18"/>
                      <a:stretch/>
                    </p:blipFill>
                    <p:spPr>
                      <a:xfrm>
                        <a:off x="1482120" y="6599160"/>
                        <a:ext cx="3308760" cy="2958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pic>
          <p:nvPicPr>
            <p:cNvPr id="71" name="Picture 19" descr=""/>
            <p:cNvPicPr/>
            <p:nvPr/>
          </p:nvPicPr>
          <p:blipFill>
            <a:blip r:embed="rId19"/>
            <a:stretch/>
          </p:blipFill>
          <p:spPr>
            <a:xfrm>
              <a:off x="1719000" y="2288880"/>
              <a:ext cx="3654360" cy="300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Εικόνα 2" descr=""/>
            <p:cNvPicPr/>
            <p:nvPr/>
          </p:nvPicPr>
          <p:blipFill>
            <a:blip r:embed="rId20"/>
            <a:stretch/>
          </p:blipFill>
          <p:spPr>
            <a:xfrm>
              <a:off x="8177040" y="2288880"/>
              <a:ext cx="3024000" cy="3660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3" name="Rectangle 29"/>
          <p:cNvSpPr/>
          <p:nvPr/>
        </p:nvSpPr>
        <p:spPr>
          <a:xfrm>
            <a:off x="138240" y="19080"/>
            <a:ext cx="6392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Additional file </a:t>
            </a:r>
            <a:r>
              <a:rPr b="1" lang="el-GR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6</a:t>
            </a: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: Figure  S</a:t>
            </a:r>
            <a:r>
              <a:rPr b="1" lang="el-GR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6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"/>
          <p:cNvSpPr/>
          <p:nvPr/>
        </p:nvSpPr>
        <p:spPr>
          <a:xfrm>
            <a:off x="5773680" y="6727680"/>
            <a:ext cx="3151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reatinine (enzymatic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9"/>
          <p:cNvSpPr/>
          <p:nvPr/>
        </p:nvSpPr>
        <p:spPr>
          <a:xfrm>
            <a:off x="10036080" y="9575640"/>
            <a:ext cx="315144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Potassium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Ομάδα 4"/>
          <p:cNvGrpSpPr/>
          <p:nvPr/>
        </p:nvGrpSpPr>
        <p:grpSpPr>
          <a:xfrm>
            <a:off x="1050840" y="128520"/>
            <a:ext cx="9810720" cy="10294920"/>
            <a:chOff x="1050840" y="128520"/>
            <a:chExt cx="9810720" cy="10294920"/>
          </a:xfrm>
        </p:grpSpPr>
        <p:grpSp>
          <p:nvGrpSpPr>
            <p:cNvPr id="77" name="Ομάδα 1"/>
            <p:cNvGrpSpPr/>
            <p:nvPr/>
          </p:nvGrpSpPr>
          <p:grpSpPr>
            <a:xfrm>
              <a:off x="1050840" y="128520"/>
              <a:ext cx="9810720" cy="5859000"/>
              <a:chOff x="1050840" y="128520"/>
              <a:chExt cx="9810720" cy="5859000"/>
            </a:xfrm>
          </p:grpSpPr>
          <p:grpSp>
            <p:nvGrpSpPr>
              <p:cNvPr id="78" name="Group 2"/>
              <p:cNvGrpSpPr/>
              <p:nvPr/>
            </p:nvGrpSpPr>
            <p:grpSpPr>
              <a:xfrm>
                <a:off x="1088640" y="128520"/>
                <a:ext cx="9772920" cy="4609800"/>
                <a:chOff x="1088640" y="128520"/>
                <a:chExt cx="9772920" cy="4609800"/>
              </a:xfrm>
            </p:grpSpPr>
            <p:pic>
              <p:nvPicPr>
                <p:cNvPr id="79" name="Picture 2" descr="I:\Aggelos Margetis 25-1-2020 usb\---ideas and projects---\PhD project-AM, ISP 9-2-2020\experimental design\in vivo\tumors photos\CTRL\F2 FINAL.jpg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1929240" y="62964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0" name="Picture 3" descr="I:\Aggelos Margetis 25-1-2020 usb\---ideas and projects---\PhD project-AM, ISP 9-2-2020\experimental design\in vivo\tumors photos\CTRL\F6 FINAL.jpg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4991760" y="62964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1" name="Picture 4" descr="I:\Aggelos Margetis 25-1-2020 usb\---ideas and projects---\PhD project-AM, ISP 9-2-2020\experimental design\in vivo\tumors photos\CTRL\F14 FINAL.jp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6522120" y="62964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2" name="Picture 6" descr="I:\Aggelos Margetis 25-1-2020 usb\---ideas and projects---\PhD project-AM, ISP 9-2-2020\experimental design\in vivo\tumors photos\CTRL\Μ12 FINAL.jp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427560" y="629640"/>
                  <a:ext cx="130140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3" name="Picture 7" descr="I:\Aggelos Margetis 25-1-2020 usb\---ideas and projects---\PhD project-AM, ISP 9-2-2020\experimental design\in vivo\tumors photos\CTRL\Μ13 FINAL.jpg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9584640" y="62964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4" name="11 - TextBox"/>
                <p:cNvSpPr/>
                <p:nvPr/>
              </p:nvSpPr>
              <p:spPr>
                <a:xfrm rot="16200000">
                  <a:off x="-438120" y="2288520"/>
                  <a:ext cx="44532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776240"/>
                      <a:tab algn="l" pos="3552840"/>
                      <a:tab algn="l" pos="5329080"/>
                      <a:tab algn="l" pos="7105680"/>
                      <a:tab algn="l" pos="8881920"/>
                      <a:tab algn="l" pos="1065852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R+DXR</a:t>
                  </a:r>
                  <a:r>
                    <a:rPr b="1" lang="el-GR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</a:t>
                  </a:r>
                  <a:r>
                    <a:rPr b="1" lang="el-GR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DXR     </a:t>
                  </a:r>
                  <a:r>
                    <a:rPr b="1" lang="el-GR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l-GR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CR    </a:t>
                  </a:r>
                  <a:r>
                    <a:rPr b="1" lang="el-GR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NTROL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85" name="Picture 8" descr="I:\Aggelos Margetis 25-1-2020 usb\---ideas and projects---\PhD project-AM, ISP 9-2-2020\experimental design\in vivo\tumors photos\DXR\F1 FINAL.jpg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3459600" y="2750760"/>
                  <a:ext cx="1269360" cy="936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6" name="Picture 9" descr="I:\Aggelos Margetis 25-1-2020 usb\---ideas and projects---\PhD project-AM, ISP 9-2-2020\experimental design\in vivo\tumors photos\DXR\F7 FINAL.jpg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6522120" y="275544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7" name="Picture 10" descr="I:\Aggelos Margetis 25-1-2020 usb\---ideas and projects---\PhD project-AM, ISP 9-2-2020\experimental design\in vivo\tumors photos\DXR\F9 FINAL.jpg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4991760" y="275544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8" name="Picture 11" descr="I:\Aggelos Margetis 25-1-2020 usb\---ideas and projects---\PhD project-AM, ISP 9-2-2020\experimental design\in vivo\tumors photos\DXR\Μ11 FINAL.jpg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1929240" y="2750760"/>
                  <a:ext cx="1275120" cy="936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9" name="Picture 12" descr="I:\Aggelos Margetis 25-1-2020 usb\---ideas and projects---\PhD project-AM, ISP 9-2-2020\experimental design\in vivo\tumors photos\CR\F3 FINAL.jpg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6522120" y="170928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0" name="Picture 13" descr="I:\Aggelos Margetis 25-1-2020 usb\---ideas and projects---\PhD project-AM, ISP 9-2-2020\experimental design\in vivo\tumors photos\CR\F4 FINAL.jpg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1929240" y="170928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1" name="Picture 14" descr="I:\Aggelos Margetis 25-1-2020 usb\---ideas and projects---\PhD project-AM, ISP 9-2-2020\experimental design\in vivo\tumors photos\CR\F8 FINAL.jpg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8054280" y="170928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2" name="Picture 15" descr="I:\Aggelos Margetis 25-1-2020 usb\---ideas and projects---\PhD project-AM, ISP 9-2-2020\experimental design\in vivo\tumors photos\CR\M2 FINAL.jpg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3459600" y="170928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3" name="Picture 16" descr="I:\Aggelos Margetis 25-1-2020 usb\---ideas and projects---\PhD project-AM, ISP 9-2-2020\experimental design\in vivo\tumors photos\CR\M14 FINAL.jpg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4991760" y="170928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4" name="Picture 17" descr="I:\Aggelos Margetis 25-1-2020 usb\---ideas and projects---\PhD project-AM, ISP 9-2-2020\experimental design\in vivo\tumors photos\CR+DXR\F5 FINAL.jpg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3459600" y="380016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5" name="Picture 18" descr="I:\Aggelos Margetis 25-1-2020 usb\---ideas and projects---\PhD project-AM, ISP 9-2-2020\experimental design\in vivo\tumors photos\CR+DXR\F11 FINAL.jpg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1929240" y="380016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6" name="Picture 19" descr="I:\Aggelos Margetis 25-1-2020 usb\---ideas and projects---\PhD project-AM, ISP 9-2-2020\experimental design\in vivo\tumors photos\CR+DXR\F15 FINAL.jpg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6522120" y="3800160"/>
                  <a:ext cx="12769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7" name="Picture 20" descr="I:\Aggelos Margetis 25-1-2020 usb\---ideas and projects---\PhD project-AM, ISP 9-2-2020\experimental design\in vivo\tumors photos\CR+DXR\M6 FINAL.jpg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8054280" y="380016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8" name="Picture 21" descr="I:\Aggelos Margetis 25-1-2020 usb\---ideas and projects---\PhD project-AM, ISP 9-2-2020\experimental design\in vivo\tumors photos\CR+DXR\M7 FINAL.jpg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8054280" y="62964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9" name="Picture 22" descr="I:\Aggelos Margetis 25-1-2020 usb\---ideas and projects---\PhD project-AM, ISP 9-2-2020\experimental design\in vivo\tumors photos\CR+DXR\Μ10 FINAL.jpg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4991760" y="3800160"/>
                  <a:ext cx="1275120" cy="938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0" name="42 - TextBox"/>
                <p:cNvSpPr/>
                <p:nvPr/>
              </p:nvSpPr>
              <p:spPr>
                <a:xfrm>
                  <a:off x="1088640" y="128520"/>
                  <a:ext cx="583920" cy="396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776240"/>
                      <a:tab algn="l" pos="3552840"/>
                      <a:tab algn="l" pos="5329080"/>
                      <a:tab algn="l" pos="7105680"/>
                      <a:tab algn="l" pos="8881920"/>
                      <a:tab algn="l" pos="1065852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d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1" name="42 - TextBox"/>
              <p:cNvSpPr/>
              <p:nvPr/>
            </p:nvSpPr>
            <p:spPr>
              <a:xfrm>
                <a:off x="1050840" y="5590800"/>
                <a:ext cx="583920" cy="39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02" name="Εικόνα 3" descr=""/>
            <p:cNvPicPr/>
            <p:nvPr/>
          </p:nvPicPr>
          <p:blipFill>
            <a:blip r:embed="rId21"/>
            <a:stretch/>
          </p:blipFill>
          <p:spPr>
            <a:xfrm>
              <a:off x="1464840" y="6238080"/>
              <a:ext cx="5931720" cy="41853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0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9T11:22:21Z</dcterms:created>
  <dc:creator>Dell User</dc:creator>
  <dc:description/>
  <dc:language>en-US</dc:language>
  <cp:lastModifiedBy>Priya V.</cp:lastModifiedBy>
  <cp:lastPrinted>2023-01-20T17:09:44Z</cp:lastPrinted>
  <dcterms:modified xsi:type="dcterms:W3CDTF">2023-02-01T04:32:44Z</dcterms:modified>
  <cp:revision>364</cp:revision>
  <dc:subject/>
  <dc:title>PowerPoint Presentation</dc:title>
</cp:coreProperties>
</file>